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94806F5-F1DD-79F5-3D8D-85F6927CF9C2}" name="Author" initials="A" userId="Author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2" d="100"/>
          <a:sy n="102" d="100"/>
        </p:scale>
        <p:origin x="144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伊藤　龍一" userId="d4b21ca6-d7a4-440c-b344-fcf63bb452b7" providerId="ADAL" clId="{DF572EBA-990F-425B-B1F5-5B4BDBA85DE5}"/>
    <pc:docChg chg="modSld">
      <pc:chgData name="伊藤　龍一" userId="d4b21ca6-d7a4-440c-b344-fcf63bb452b7" providerId="ADAL" clId="{DF572EBA-990F-425B-B1F5-5B4BDBA85DE5}" dt="2023-01-12T10:37:55.505" v="22"/>
      <pc:docMkLst>
        <pc:docMk/>
      </pc:docMkLst>
      <pc:sldChg chg="addSp delSp modSp mod">
        <pc:chgData name="伊藤　龍一" userId="d4b21ca6-d7a4-440c-b344-fcf63bb452b7" providerId="ADAL" clId="{DF572EBA-990F-425B-B1F5-5B4BDBA85DE5}" dt="2023-01-12T10:37:55.505" v="22"/>
        <pc:sldMkLst>
          <pc:docMk/>
          <pc:sldMk cId="1738469105" sldId="256"/>
        </pc:sldMkLst>
        <pc:spChg chg="mod">
          <ac:chgData name="伊藤　龍一" userId="d4b21ca6-d7a4-440c-b344-fcf63bb452b7" providerId="ADAL" clId="{DF572EBA-990F-425B-B1F5-5B4BDBA85DE5}" dt="2023-01-12T10:37:34.109" v="10"/>
          <ac:spMkLst>
            <pc:docMk/>
            <pc:sldMk cId="1738469105" sldId="256"/>
            <ac:spMk id="3" creationId="{2D726094-D7FB-412A-A4F8-C175E7D922D8}"/>
          </ac:spMkLst>
        </pc:spChg>
        <pc:spChg chg="mod">
          <ac:chgData name="伊藤　龍一" userId="d4b21ca6-d7a4-440c-b344-fcf63bb452b7" providerId="ADAL" clId="{DF572EBA-990F-425B-B1F5-5B4BDBA85DE5}" dt="2023-01-12T10:37:50.001" v="17"/>
          <ac:spMkLst>
            <pc:docMk/>
            <pc:sldMk cId="1738469105" sldId="256"/>
            <ac:spMk id="6" creationId="{4F0F5389-4B5C-43A6-B294-87D22A8517EC}"/>
          </ac:spMkLst>
        </pc:spChg>
        <pc:spChg chg="mod">
          <ac:chgData name="伊藤　龍一" userId="d4b21ca6-d7a4-440c-b344-fcf63bb452b7" providerId="ADAL" clId="{DF572EBA-990F-425B-B1F5-5B4BDBA85DE5}" dt="2023-01-12T10:37:55.505" v="22"/>
          <ac:spMkLst>
            <pc:docMk/>
            <pc:sldMk cId="1738469105" sldId="256"/>
            <ac:spMk id="15" creationId="{1912A505-E4CC-1EA7-5475-C8171DA061A0}"/>
          </ac:spMkLst>
        </pc:spChg>
        <pc:graphicFrameChg chg="add del mod">
          <ac:chgData name="伊藤　龍一" userId="d4b21ca6-d7a4-440c-b344-fcf63bb452b7" providerId="ADAL" clId="{DF572EBA-990F-425B-B1F5-5B4BDBA85DE5}" dt="2023-01-12T10:37:42.237" v="12"/>
          <ac:graphicFrameMkLst>
            <pc:docMk/>
            <pc:sldMk cId="1738469105" sldId="256"/>
            <ac:graphicFrameMk id="7" creationId="{5D20E5D8-299E-9C7C-1017-3CDF2E2E2422}"/>
          </ac:graphicFrameMkLst>
        </pc:graphicFrameChg>
      </pc:sldChg>
    </pc:docChg>
  </pc:docChgLst>
  <pc:docChgLst>
    <pc:chgData name="伊藤　龍一" userId="7a7b1a2d-586b-45bc-81a4-27dde9083320" providerId="ADAL" clId="{E53D55D4-D5C8-4C50-9F67-AB8F316CDC47}"/>
    <pc:docChg chg="modSld">
      <pc:chgData name="伊藤　龍一" userId="7a7b1a2d-586b-45bc-81a4-27dde9083320" providerId="ADAL" clId="{E53D55D4-D5C8-4C50-9F67-AB8F316CDC47}" dt="2022-04-11T06:13:16.932" v="32" actId="12788"/>
      <pc:docMkLst>
        <pc:docMk/>
      </pc:docMkLst>
      <pc:sldChg chg="addSp modSp mod">
        <pc:chgData name="伊藤　龍一" userId="7a7b1a2d-586b-45bc-81a4-27dde9083320" providerId="ADAL" clId="{E53D55D4-D5C8-4C50-9F67-AB8F316CDC47}" dt="2022-04-11T06:13:16.932" v="32" actId="12788"/>
        <pc:sldMkLst>
          <pc:docMk/>
          <pc:sldMk cId="1738469105" sldId="256"/>
        </pc:sldMkLst>
        <pc:spChg chg="mod">
          <ac:chgData name="伊藤　龍一" userId="7a7b1a2d-586b-45bc-81a4-27dde9083320" providerId="ADAL" clId="{E53D55D4-D5C8-4C50-9F67-AB8F316CDC47}" dt="2022-04-11T06:13:02.639" v="17" actId="1036"/>
          <ac:spMkLst>
            <pc:docMk/>
            <pc:sldMk cId="1738469105" sldId="256"/>
            <ac:spMk id="2" creationId="{C104C083-B018-4105-855D-83181E53D694}"/>
          </ac:spMkLst>
        </pc:spChg>
        <pc:spChg chg="mod">
          <ac:chgData name="伊藤　龍一" userId="7a7b1a2d-586b-45bc-81a4-27dde9083320" providerId="ADAL" clId="{E53D55D4-D5C8-4C50-9F67-AB8F316CDC47}" dt="2022-04-11T06:13:02.639" v="17" actId="1036"/>
          <ac:spMkLst>
            <pc:docMk/>
            <pc:sldMk cId="1738469105" sldId="256"/>
            <ac:spMk id="3" creationId="{2D726094-D7FB-412A-A4F8-C175E7D922D8}"/>
          </ac:spMkLst>
        </pc:spChg>
        <pc:spChg chg="mod">
          <ac:chgData name="伊藤　龍一" userId="7a7b1a2d-586b-45bc-81a4-27dde9083320" providerId="ADAL" clId="{E53D55D4-D5C8-4C50-9F67-AB8F316CDC47}" dt="2022-04-11T06:13:02.639" v="17" actId="1036"/>
          <ac:spMkLst>
            <pc:docMk/>
            <pc:sldMk cId="1738469105" sldId="256"/>
            <ac:spMk id="4" creationId="{FB5A1A4B-4481-4352-8CB9-D83D9B9D72B0}"/>
          </ac:spMkLst>
        </pc:spChg>
        <pc:spChg chg="mod">
          <ac:chgData name="伊藤　龍一" userId="7a7b1a2d-586b-45bc-81a4-27dde9083320" providerId="ADAL" clId="{E53D55D4-D5C8-4C50-9F67-AB8F316CDC47}" dt="2022-04-11T06:13:02.639" v="17" actId="1036"/>
          <ac:spMkLst>
            <pc:docMk/>
            <pc:sldMk cId="1738469105" sldId="256"/>
            <ac:spMk id="5" creationId="{C3BC6EA8-3C2C-40BD-9F87-A9FFFE00B6EC}"/>
          </ac:spMkLst>
        </pc:spChg>
        <pc:spChg chg="mod">
          <ac:chgData name="伊藤　龍一" userId="7a7b1a2d-586b-45bc-81a4-27dde9083320" providerId="ADAL" clId="{E53D55D4-D5C8-4C50-9F67-AB8F316CDC47}" dt="2022-04-11T06:13:02.639" v="17" actId="1036"/>
          <ac:spMkLst>
            <pc:docMk/>
            <pc:sldMk cId="1738469105" sldId="256"/>
            <ac:spMk id="6" creationId="{4F0F5389-4B5C-43A6-B294-87D22A8517EC}"/>
          </ac:spMkLst>
        </pc:spChg>
        <pc:spChg chg="add mod">
          <ac:chgData name="伊藤　龍一" userId="7a7b1a2d-586b-45bc-81a4-27dde9083320" providerId="ADAL" clId="{E53D55D4-D5C8-4C50-9F67-AB8F316CDC47}" dt="2022-04-11T06:13:16.932" v="32" actId="12788"/>
          <ac:spMkLst>
            <pc:docMk/>
            <pc:sldMk cId="1738469105" sldId="256"/>
            <ac:spMk id="11" creationId="{99A6F63B-62F9-448C-8B1D-DDA289EB4FEE}"/>
          </ac:spMkLst>
        </pc:spChg>
        <pc:cxnChg chg="mod">
          <ac:chgData name="伊藤　龍一" userId="7a7b1a2d-586b-45bc-81a4-27dde9083320" providerId="ADAL" clId="{E53D55D4-D5C8-4C50-9F67-AB8F316CDC47}" dt="2022-04-11T06:13:02.639" v="17" actId="1036"/>
          <ac:cxnSpMkLst>
            <pc:docMk/>
            <pc:sldMk cId="1738469105" sldId="256"/>
            <ac:cxnSpMk id="8" creationId="{6EC8EC20-9B98-4239-B0B2-065AEB709A5B}"/>
          </ac:cxnSpMkLst>
        </pc:cxnChg>
        <pc:cxnChg chg="mod">
          <ac:chgData name="伊藤　龍一" userId="7a7b1a2d-586b-45bc-81a4-27dde9083320" providerId="ADAL" clId="{E53D55D4-D5C8-4C50-9F67-AB8F316CDC47}" dt="2022-04-11T06:13:02.639" v="17" actId="1036"/>
          <ac:cxnSpMkLst>
            <pc:docMk/>
            <pc:sldMk cId="1738469105" sldId="256"/>
            <ac:cxnSpMk id="9" creationId="{1B714BB7-3D65-4BA1-B88A-2D452C8E0760}"/>
          </ac:cxnSpMkLst>
        </pc:cxnChg>
        <pc:cxnChg chg="mod">
          <ac:chgData name="伊藤　龍一" userId="7a7b1a2d-586b-45bc-81a4-27dde9083320" providerId="ADAL" clId="{E53D55D4-D5C8-4C50-9F67-AB8F316CDC47}" dt="2022-04-11T06:13:02.639" v="17" actId="1036"/>
          <ac:cxnSpMkLst>
            <pc:docMk/>
            <pc:sldMk cId="1738469105" sldId="256"/>
            <ac:cxnSpMk id="13" creationId="{3CDDF287-E534-436E-A780-A65979B04B81}"/>
          </ac:cxnSpMkLst>
        </pc:cxnChg>
        <pc:cxnChg chg="mod">
          <ac:chgData name="伊藤　龍一" userId="7a7b1a2d-586b-45bc-81a4-27dde9083320" providerId="ADAL" clId="{E53D55D4-D5C8-4C50-9F67-AB8F316CDC47}" dt="2022-04-11T06:13:02.639" v="17" actId="1036"/>
          <ac:cxnSpMkLst>
            <pc:docMk/>
            <pc:sldMk cId="1738469105" sldId="256"/>
            <ac:cxnSpMk id="14" creationId="{2C298B70-953B-4F5C-A3B5-23E4A98384CD}"/>
          </ac:cxnSpMkLst>
        </pc:cxnChg>
      </pc:sldChg>
    </pc:docChg>
  </pc:docChgLst>
  <pc:docChgLst>
    <pc:chgData name="伊藤　龍一" userId="7a7b1a2d-586b-45bc-81a4-27dde9083320" providerId="ADAL" clId="{0957C9F7-DCB9-4C9F-A8DE-0486463DA4B2}"/>
    <pc:docChg chg="undo custSel modSld">
      <pc:chgData name="伊藤　龍一" userId="7a7b1a2d-586b-45bc-81a4-27dde9083320" providerId="ADAL" clId="{0957C9F7-DCB9-4C9F-A8DE-0486463DA4B2}" dt="2022-02-10T07:41:54.980" v="366" actId="20577"/>
      <pc:docMkLst>
        <pc:docMk/>
      </pc:docMkLst>
      <pc:sldChg chg="addSp delSp modSp mod">
        <pc:chgData name="伊藤　龍一" userId="7a7b1a2d-586b-45bc-81a4-27dde9083320" providerId="ADAL" clId="{0957C9F7-DCB9-4C9F-A8DE-0486463DA4B2}" dt="2022-02-10T07:41:54.980" v="366" actId="20577"/>
        <pc:sldMkLst>
          <pc:docMk/>
          <pc:sldMk cId="1738469105" sldId="256"/>
        </pc:sldMkLst>
        <pc:spChg chg="mod">
          <ac:chgData name="伊藤　龍一" userId="7a7b1a2d-586b-45bc-81a4-27dde9083320" providerId="ADAL" clId="{0957C9F7-DCB9-4C9F-A8DE-0486463DA4B2}" dt="2022-02-10T07:38:08.002" v="265" actId="207"/>
          <ac:spMkLst>
            <pc:docMk/>
            <pc:sldMk cId="1738469105" sldId="256"/>
            <ac:spMk id="2" creationId="{C104C083-B018-4105-855D-83181E53D694}"/>
          </ac:spMkLst>
        </pc:spChg>
        <pc:spChg chg="mod">
          <ac:chgData name="伊藤　龍一" userId="7a7b1a2d-586b-45bc-81a4-27dde9083320" providerId="ADAL" clId="{0957C9F7-DCB9-4C9F-A8DE-0486463DA4B2}" dt="2022-02-10T07:41:01.058" v="349" actId="1038"/>
          <ac:spMkLst>
            <pc:docMk/>
            <pc:sldMk cId="1738469105" sldId="256"/>
            <ac:spMk id="3" creationId="{2D726094-D7FB-412A-A4F8-C175E7D922D8}"/>
          </ac:spMkLst>
        </pc:spChg>
        <pc:spChg chg="mod">
          <ac:chgData name="伊藤　龍一" userId="7a7b1a2d-586b-45bc-81a4-27dde9083320" providerId="ADAL" clId="{0957C9F7-DCB9-4C9F-A8DE-0486463DA4B2}" dt="2022-02-10T07:38:03.741" v="262" actId="207"/>
          <ac:spMkLst>
            <pc:docMk/>
            <pc:sldMk cId="1738469105" sldId="256"/>
            <ac:spMk id="4" creationId="{FB5A1A4B-4481-4352-8CB9-D83D9B9D72B0}"/>
          </ac:spMkLst>
        </pc:spChg>
        <pc:spChg chg="mod">
          <ac:chgData name="伊藤　龍一" userId="7a7b1a2d-586b-45bc-81a4-27dde9083320" providerId="ADAL" clId="{0957C9F7-DCB9-4C9F-A8DE-0486463DA4B2}" dt="2022-02-10T07:41:01.058" v="349" actId="1038"/>
          <ac:spMkLst>
            <pc:docMk/>
            <pc:sldMk cId="1738469105" sldId="256"/>
            <ac:spMk id="5" creationId="{C3BC6EA8-3C2C-40BD-9F87-A9FFFE00B6EC}"/>
          </ac:spMkLst>
        </pc:spChg>
        <pc:spChg chg="mod">
          <ac:chgData name="伊藤　龍一" userId="7a7b1a2d-586b-45bc-81a4-27dde9083320" providerId="ADAL" clId="{0957C9F7-DCB9-4C9F-A8DE-0486463DA4B2}" dt="2022-02-10T07:41:54.980" v="366" actId="20577"/>
          <ac:spMkLst>
            <pc:docMk/>
            <pc:sldMk cId="1738469105" sldId="256"/>
            <ac:spMk id="6" creationId="{4F0F5389-4B5C-43A6-B294-87D22A8517EC}"/>
          </ac:spMkLst>
        </pc:spChg>
        <pc:spChg chg="add del mod">
          <ac:chgData name="伊藤　龍一" userId="7a7b1a2d-586b-45bc-81a4-27dde9083320" providerId="ADAL" clId="{0957C9F7-DCB9-4C9F-A8DE-0486463DA4B2}" dt="2022-02-10T01:28:41.781" v="59" actId="478"/>
          <ac:spMkLst>
            <pc:docMk/>
            <pc:sldMk cId="1738469105" sldId="256"/>
            <ac:spMk id="7" creationId="{23E407DA-12E2-445B-9998-89B284D85EA0}"/>
          </ac:spMkLst>
        </pc:spChg>
        <pc:cxnChg chg="add mod">
          <ac:chgData name="伊藤　龍一" userId="7a7b1a2d-586b-45bc-81a4-27dde9083320" providerId="ADAL" clId="{0957C9F7-DCB9-4C9F-A8DE-0486463DA4B2}" dt="2022-02-10T07:41:01.058" v="349" actId="1038"/>
          <ac:cxnSpMkLst>
            <pc:docMk/>
            <pc:sldMk cId="1738469105" sldId="256"/>
            <ac:cxnSpMk id="8" creationId="{6EC8EC20-9B98-4239-B0B2-065AEB709A5B}"/>
          </ac:cxnSpMkLst>
        </pc:cxnChg>
        <pc:cxnChg chg="add mod">
          <ac:chgData name="伊藤　龍一" userId="7a7b1a2d-586b-45bc-81a4-27dde9083320" providerId="ADAL" clId="{0957C9F7-DCB9-4C9F-A8DE-0486463DA4B2}" dt="2022-02-10T07:41:01.058" v="349" actId="1038"/>
          <ac:cxnSpMkLst>
            <pc:docMk/>
            <pc:sldMk cId="1738469105" sldId="256"/>
            <ac:cxnSpMk id="9" creationId="{1B714BB7-3D65-4BA1-B88A-2D452C8E0760}"/>
          </ac:cxnSpMkLst>
        </pc:cxnChg>
        <pc:cxnChg chg="add mod">
          <ac:chgData name="伊藤　龍一" userId="7a7b1a2d-586b-45bc-81a4-27dde9083320" providerId="ADAL" clId="{0957C9F7-DCB9-4C9F-A8DE-0486463DA4B2}" dt="2022-02-10T07:41:01.058" v="349" actId="1038"/>
          <ac:cxnSpMkLst>
            <pc:docMk/>
            <pc:sldMk cId="1738469105" sldId="256"/>
            <ac:cxnSpMk id="13" creationId="{3CDDF287-E534-436E-A780-A65979B04B81}"/>
          </ac:cxnSpMkLst>
        </pc:cxnChg>
        <pc:cxnChg chg="add mod">
          <ac:chgData name="伊藤　龍一" userId="7a7b1a2d-586b-45bc-81a4-27dde9083320" providerId="ADAL" clId="{0957C9F7-DCB9-4C9F-A8DE-0486463DA4B2}" dt="2022-02-10T07:41:01.058" v="349" actId="1038"/>
          <ac:cxnSpMkLst>
            <pc:docMk/>
            <pc:sldMk cId="1738469105" sldId="256"/>
            <ac:cxnSpMk id="14" creationId="{2C298B70-953B-4F5C-A3B5-23E4A98384CD}"/>
          </ac:cxnSpMkLst>
        </pc:cxnChg>
      </pc:sldChg>
    </pc:docChg>
  </pc:docChgLst>
  <pc:docChgLst>
    <pc:chgData name="伊藤　龍一" userId="7a7b1a2d-586b-45bc-81a4-27dde9083320" providerId="ADAL" clId="{3F688639-E19D-429E-B24B-A5C004E250FB}"/>
    <pc:docChg chg="custSel addSld modSld">
      <pc:chgData name="伊藤　龍一" userId="7a7b1a2d-586b-45bc-81a4-27dde9083320" providerId="ADAL" clId="{3F688639-E19D-429E-B24B-A5C004E250FB}" dt="2022-02-09T15:07:52.028" v="454" actId="20577"/>
      <pc:docMkLst>
        <pc:docMk/>
      </pc:docMkLst>
      <pc:sldChg chg="addSp modSp new mod">
        <pc:chgData name="伊藤　龍一" userId="7a7b1a2d-586b-45bc-81a4-27dde9083320" providerId="ADAL" clId="{3F688639-E19D-429E-B24B-A5C004E250FB}" dt="2022-02-09T15:07:52.028" v="454" actId="20577"/>
        <pc:sldMkLst>
          <pc:docMk/>
          <pc:sldMk cId="1738469105" sldId="256"/>
        </pc:sldMkLst>
        <pc:spChg chg="add mod">
          <ac:chgData name="伊藤　龍一" userId="7a7b1a2d-586b-45bc-81a4-27dde9083320" providerId="ADAL" clId="{3F688639-E19D-429E-B24B-A5C004E250FB}" dt="2022-02-09T15:04:35.045" v="316" actId="20577"/>
          <ac:spMkLst>
            <pc:docMk/>
            <pc:sldMk cId="1738469105" sldId="256"/>
            <ac:spMk id="2" creationId="{C104C083-B018-4105-855D-83181E53D694}"/>
          </ac:spMkLst>
        </pc:spChg>
        <pc:spChg chg="add mod">
          <ac:chgData name="伊藤　龍一" userId="7a7b1a2d-586b-45bc-81a4-27dde9083320" providerId="ADAL" clId="{3F688639-E19D-429E-B24B-A5C004E250FB}" dt="2022-02-09T15:07:42.459" v="450" actId="20577"/>
          <ac:spMkLst>
            <pc:docMk/>
            <pc:sldMk cId="1738469105" sldId="256"/>
            <ac:spMk id="3" creationId="{2D726094-D7FB-412A-A4F8-C175E7D922D8}"/>
          </ac:spMkLst>
        </pc:spChg>
        <pc:spChg chg="add mod">
          <ac:chgData name="伊藤　龍一" userId="7a7b1a2d-586b-45bc-81a4-27dde9083320" providerId="ADAL" clId="{3F688639-E19D-429E-B24B-A5C004E250FB}" dt="2022-02-09T15:07:34.163" v="446" actId="20577"/>
          <ac:spMkLst>
            <pc:docMk/>
            <pc:sldMk cId="1738469105" sldId="256"/>
            <ac:spMk id="4" creationId="{FB5A1A4B-4481-4352-8CB9-D83D9B9D72B0}"/>
          </ac:spMkLst>
        </pc:spChg>
        <pc:spChg chg="add mod">
          <ac:chgData name="伊藤　龍一" userId="7a7b1a2d-586b-45bc-81a4-27dde9083320" providerId="ADAL" clId="{3F688639-E19D-429E-B24B-A5C004E250FB}" dt="2022-02-09T15:05:10.835" v="348" actId="20577"/>
          <ac:spMkLst>
            <pc:docMk/>
            <pc:sldMk cId="1738469105" sldId="256"/>
            <ac:spMk id="5" creationId="{C3BC6EA8-3C2C-40BD-9F87-A9FFFE00B6EC}"/>
          </ac:spMkLst>
        </pc:spChg>
        <pc:spChg chg="add mod">
          <ac:chgData name="伊藤　龍一" userId="7a7b1a2d-586b-45bc-81a4-27dde9083320" providerId="ADAL" clId="{3F688639-E19D-429E-B24B-A5C004E250FB}" dt="2022-02-09T15:07:52.028" v="454" actId="20577"/>
          <ac:spMkLst>
            <pc:docMk/>
            <pc:sldMk cId="1738469105" sldId="256"/>
            <ac:spMk id="6" creationId="{4F0F5389-4B5C-43A6-B294-87D22A8517EC}"/>
          </ac:spMkLst>
        </pc:spChg>
      </pc:sldChg>
    </pc:docChg>
  </pc:docChgLst>
  <pc:docChgLst>
    <pc:chgData name="伊藤　龍一" userId="d4b21ca6-d7a4-440c-b344-fcf63bb452b7" providerId="ADAL" clId="{64BE3855-E232-4381-AB28-47B28D1F7073}"/>
    <pc:docChg chg="undo custSel modSld">
      <pc:chgData name="伊藤　龍一" userId="d4b21ca6-d7a4-440c-b344-fcf63bb452b7" providerId="ADAL" clId="{64BE3855-E232-4381-AB28-47B28D1F7073}" dt="2022-11-18T08:29:31.256" v="369" actId="113"/>
      <pc:docMkLst>
        <pc:docMk/>
      </pc:docMkLst>
      <pc:sldChg chg="addSp delSp modSp mod delCm">
        <pc:chgData name="伊藤　龍一" userId="d4b21ca6-d7a4-440c-b344-fcf63bb452b7" providerId="ADAL" clId="{64BE3855-E232-4381-AB28-47B28D1F7073}" dt="2022-11-18T08:29:31.256" v="369" actId="113"/>
        <pc:sldMkLst>
          <pc:docMk/>
          <pc:sldMk cId="1738469105" sldId="256"/>
        </pc:sldMkLst>
        <pc:spChg chg="mod">
          <ac:chgData name="伊藤　龍一" userId="d4b21ca6-d7a4-440c-b344-fcf63bb452b7" providerId="ADAL" clId="{64BE3855-E232-4381-AB28-47B28D1F7073}" dt="2022-11-14T07:09:05.695" v="308" actId="1035"/>
          <ac:spMkLst>
            <pc:docMk/>
            <pc:sldMk cId="1738469105" sldId="256"/>
            <ac:spMk id="2" creationId="{C104C083-B018-4105-855D-83181E53D694}"/>
          </ac:spMkLst>
        </pc:spChg>
        <pc:spChg chg="mod">
          <ac:chgData name="伊藤　龍一" userId="d4b21ca6-d7a4-440c-b344-fcf63bb452b7" providerId="ADAL" clId="{64BE3855-E232-4381-AB28-47B28D1F7073}" dt="2022-11-15T12:17:46.132" v="342" actId="2711"/>
          <ac:spMkLst>
            <pc:docMk/>
            <pc:sldMk cId="1738469105" sldId="256"/>
            <ac:spMk id="3" creationId="{2D726094-D7FB-412A-A4F8-C175E7D922D8}"/>
          </ac:spMkLst>
        </pc:spChg>
        <pc:spChg chg="mod">
          <ac:chgData name="伊藤　龍一" userId="d4b21ca6-d7a4-440c-b344-fcf63bb452b7" providerId="ADAL" clId="{64BE3855-E232-4381-AB28-47B28D1F7073}" dt="2022-11-15T12:18:22.147" v="346" actId="20577"/>
          <ac:spMkLst>
            <pc:docMk/>
            <pc:sldMk cId="1738469105" sldId="256"/>
            <ac:spMk id="4" creationId="{FB5A1A4B-4481-4352-8CB9-D83D9B9D72B0}"/>
          </ac:spMkLst>
        </pc:spChg>
        <pc:spChg chg="mod">
          <ac:chgData name="伊藤　龍一" userId="d4b21ca6-d7a4-440c-b344-fcf63bb452b7" providerId="ADAL" clId="{64BE3855-E232-4381-AB28-47B28D1F7073}" dt="2022-11-14T07:09:05.695" v="308" actId="1035"/>
          <ac:spMkLst>
            <pc:docMk/>
            <pc:sldMk cId="1738469105" sldId="256"/>
            <ac:spMk id="5" creationId="{C3BC6EA8-3C2C-40BD-9F87-A9FFFE00B6EC}"/>
          </ac:spMkLst>
        </pc:spChg>
        <pc:spChg chg="mod">
          <ac:chgData name="伊藤　龍一" userId="d4b21ca6-d7a4-440c-b344-fcf63bb452b7" providerId="ADAL" clId="{64BE3855-E232-4381-AB28-47B28D1F7073}" dt="2022-11-15T12:18:12.805" v="344" actId="20577"/>
          <ac:spMkLst>
            <pc:docMk/>
            <pc:sldMk cId="1738469105" sldId="256"/>
            <ac:spMk id="6" creationId="{4F0F5389-4B5C-43A6-B294-87D22A8517EC}"/>
          </ac:spMkLst>
        </pc:spChg>
        <pc:spChg chg="add del mod">
          <ac:chgData name="伊藤　龍一" userId="d4b21ca6-d7a4-440c-b344-fcf63bb452b7" providerId="ADAL" clId="{64BE3855-E232-4381-AB28-47B28D1F7073}" dt="2022-07-12T04:49:30.242" v="26"/>
          <ac:spMkLst>
            <pc:docMk/>
            <pc:sldMk cId="1738469105" sldId="256"/>
            <ac:spMk id="7" creationId="{DE1B6892-185D-79EF-0D79-5FA44A3291CC}"/>
          </ac:spMkLst>
        </pc:spChg>
        <pc:spChg chg="add del mod">
          <ac:chgData name="伊藤　龍一" userId="d4b21ca6-d7a4-440c-b344-fcf63bb452b7" providerId="ADAL" clId="{64BE3855-E232-4381-AB28-47B28D1F7073}" dt="2022-07-12T04:51:22.070" v="88" actId="478"/>
          <ac:spMkLst>
            <pc:docMk/>
            <pc:sldMk cId="1738469105" sldId="256"/>
            <ac:spMk id="10" creationId="{D7C69F6B-1A57-3DC1-E038-BD32F4691E28}"/>
          </ac:spMkLst>
        </pc:spChg>
        <pc:spChg chg="mod">
          <ac:chgData name="伊藤　龍一" userId="d4b21ca6-d7a4-440c-b344-fcf63bb452b7" providerId="ADAL" clId="{64BE3855-E232-4381-AB28-47B28D1F7073}" dt="2022-11-18T07:52:44.812" v="368" actId="20577"/>
          <ac:spMkLst>
            <pc:docMk/>
            <pc:sldMk cId="1738469105" sldId="256"/>
            <ac:spMk id="11" creationId="{99A6F63B-62F9-448C-8B1D-DDA289EB4FEE}"/>
          </ac:spMkLst>
        </pc:spChg>
        <pc:spChg chg="add del mod">
          <ac:chgData name="伊藤　龍一" userId="d4b21ca6-d7a4-440c-b344-fcf63bb452b7" providerId="ADAL" clId="{64BE3855-E232-4381-AB28-47B28D1F7073}" dt="2022-07-12T05:02:15.077" v="115"/>
          <ac:spMkLst>
            <pc:docMk/>
            <pc:sldMk cId="1738469105" sldId="256"/>
            <ac:spMk id="12" creationId="{D34769C0-5331-9465-8477-48D9CC79BBD8}"/>
          </ac:spMkLst>
        </pc:spChg>
        <pc:spChg chg="add mod">
          <ac:chgData name="伊藤　龍一" userId="d4b21ca6-d7a4-440c-b344-fcf63bb452b7" providerId="ADAL" clId="{64BE3855-E232-4381-AB28-47B28D1F7073}" dt="2022-11-18T08:29:31.256" v="369" actId="113"/>
          <ac:spMkLst>
            <pc:docMk/>
            <pc:sldMk cId="1738469105" sldId="256"/>
            <ac:spMk id="15" creationId="{1912A505-E4CC-1EA7-5475-C8171DA061A0}"/>
          </ac:spMkLst>
        </pc:spChg>
        <pc:cxnChg chg="mod">
          <ac:chgData name="伊藤　龍一" userId="d4b21ca6-d7a4-440c-b344-fcf63bb452b7" providerId="ADAL" clId="{64BE3855-E232-4381-AB28-47B28D1F7073}" dt="2022-11-14T07:09:05.695" v="308" actId="1035"/>
          <ac:cxnSpMkLst>
            <pc:docMk/>
            <pc:sldMk cId="1738469105" sldId="256"/>
            <ac:cxnSpMk id="8" creationId="{6EC8EC20-9B98-4239-B0B2-065AEB709A5B}"/>
          </ac:cxnSpMkLst>
        </pc:cxnChg>
        <pc:cxnChg chg="mod">
          <ac:chgData name="伊藤　龍一" userId="d4b21ca6-d7a4-440c-b344-fcf63bb452b7" providerId="ADAL" clId="{64BE3855-E232-4381-AB28-47B28D1F7073}" dt="2022-11-14T07:09:05.695" v="308" actId="1035"/>
          <ac:cxnSpMkLst>
            <pc:docMk/>
            <pc:sldMk cId="1738469105" sldId="256"/>
            <ac:cxnSpMk id="9" creationId="{1B714BB7-3D65-4BA1-B88A-2D452C8E0760}"/>
          </ac:cxnSpMkLst>
        </pc:cxnChg>
        <pc:cxnChg chg="mod">
          <ac:chgData name="伊藤　龍一" userId="d4b21ca6-d7a4-440c-b344-fcf63bb452b7" providerId="ADAL" clId="{64BE3855-E232-4381-AB28-47B28D1F7073}" dt="2022-11-14T07:09:05.695" v="308" actId="1035"/>
          <ac:cxnSpMkLst>
            <pc:docMk/>
            <pc:sldMk cId="1738469105" sldId="256"/>
            <ac:cxnSpMk id="13" creationId="{3CDDF287-E534-436E-A780-A65979B04B81}"/>
          </ac:cxnSpMkLst>
        </pc:cxnChg>
        <pc:cxnChg chg="mod">
          <ac:chgData name="伊藤　龍一" userId="d4b21ca6-d7a4-440c-b344-fcf63bb452b7" providerId="ADAL" clId="{64BE3855-E232-4381-AB28-47B28D1F7073}" dt="2022-11-14T07:09:05.695" v="308" actId="1035"/>
          <ac:cxnSpMkLst>
            <pc:docMk/>
            <pc:sldMk cId="1738469105" sldId="256"/>
            <ac:cxnSpMk id="14" creationId="{2C298B70-953B-4F5C-A3B5-23E4A98384CD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3B92CC-533F-4B2A-95C5-ED3BD7B736F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21034D9-36F3-4BB8-B97D-2F21E67E241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8FFB3A8-8316-472C-91A0-9C59BAFEAB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14A40A-66D0-4BAE-9143-43D53B3CEBAB}" type="datetimeFigureOut">
              <a:rPr kumimoji="1" lang="ja-JP" altLang="en-US" smtClean="0"/>
              <a:t>2023/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B038C56-4624-498C-B220-C19456D964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76B5864-746C-4BA1-9FD8-6F0FF3987C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5DC5-1FF3-4E8E-8076-08F2EA2F0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1660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066013-8704-45B6-AB86-BA860D7358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4F1CD03-6E2A-4D00-80AE-8D0F90ECF7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E6887E6-46F2-40E0-8BD7-4A84325355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14A40A-66D0-4BAE-9143-43D53B3CEBAB}" type="datetimeFigureOut">
              <a:rPr kumimoji="1" lang="ja-JP" altLang="en-US" smtClean="0"/>
              <a:t>2023/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98B4CB0-00EF-4B8C-A7E6-1DF078540C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D32EC7D-7AFD-4670-98EC-B20A3445FC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5DC5-1FF3-4E8E-8076-08F2EA2F0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38555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8E9FA1E-FCD6-41D9-992A-53D409FDC1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74613D4-131C-45A6-8038-CF84D164F7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BFBDCEE-DCFF-4A71-BC53-966DA4F819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14A40A-66D0-4BAE-9143-43D53B3CEBAB}" type="datetimeFigureOut">
              <a:rPr kumimoji="1" lang="ja-JP" altLang="en-US" smtClean="0"/>
              <a:t>2023/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73F7128-707D-4F38-9EF5-DE6B2D3AF2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A1FBE63-E79C-44A5-BD35-ACD4F0843C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5DC5-1FF3-4E8E-8076-08F2EA2F0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86404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45804EF-B8C7-4248-A37E-E9561CDB97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52345B8-968E-4C4E-8002-5E351C09DC6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47FC349-3962-40D5-BB1B-7EF9B2B273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14A40A-66D0-4BAE-9143-43D53B3CEBAB}" type="datetimeFigureOut">
              <a:rPr kumimoji="1" lang="ja-JP" altLang="en-US" smtClean="0"/>
              <a:t>2023/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F2A7719-9FC6-4DCB-B59F-D39E7F21BB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1A4F5FE-F579-490A-98EF-7A60750A3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5DC5-1FF3-4E8E-8076-08F2EA2F0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19710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BB77866-838D-4BF7-A9A3-3257D60500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BB5E692-E68A-4AD8-95B2-3FF3BD4952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B70BB50-2C80-41FA-A432-28FD878207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14A40A-66D0-4BAE-9143-43D53B3CEBAB}" type="datetimeFigureOut">
              <a:rPr kumimoji="1" lang="ja-JP" altLang="en-US" smtClean="0"/>
              <a:t>2023/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6B01F6A-2F00-4A93-AE05-754AED5F3A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F0DED42-FBCF-445F-85CD-19F5ADE482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5DC5-1FF3-4E8E-8076-08F2EA2F0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92907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9423476-54B3-4EC0-9792-FE7E7237D6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642AF9B-BC7D-4F82-9B77-95C6E573CE3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0C02B82-BD10-480A-902F-E28CFBF197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9877C58-8AAE-4022-A033-320FE10E6F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14A40A-66D0-4BAE-9143-43D53B3CEBAB}" type="datetimeFigureOut">
              <a:rPr kumimoji="1" lang="ja-JP" altLang="en-US" smtClean="0"/>
              <a:t>2023/1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BC1FD8E-62D3-41C3-9F51-F88222204C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5D794BF-379B-4732-96E0-3230D5C4FA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5DC5-1FF3-4E8E-8076-08F2EA2F0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712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133E829-56EC-431F-9B8B-2583578DEF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1534278-4E4D-45F8-A658-FACA1E6089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F8A9A3D-B342-40FC-A476-36E9DB94D7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F4F6870-FD2F-463B-BF41-8654E592B1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6D0CEC4-F802-423D-A7DC-994614FE63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7FDC5F1-FD76-4BA8-90AD-B45C1324F6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14A40A-66D0-4BAE-9143-43D53B3CEBAB}" type="datetimeFigureOut">
              <a:rPr kumimoji="1" lang="ja-JP" altLang="en-US" smtClean="0"/>
              <a:t>2023/1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2A2AB43-FCDB-4FE5-A98F-B85348B49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5C1C8D0-E31D-46C5-A70D-BA3FAD50D2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5DC5-1FF3-4E8E-8076-08F2EA2F0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07054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1FEF869-343B-43F8-A49A-427C29FAED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DBE25BF-9835-4D66-A1CF-71A8B1A934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14A40A-66D0-4BAE-9143-43D53B3CEBAB}" type="datetimeFigureOut">
              <a:rPr kumimoji="1" lang="ja-JP" altLang="en-US" smtClean="0"/>
              <a:t>2023/1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BB4BD3A-4C95-451D-9338-667EBB8DD1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CA215B6-28A3-40E0-8823-ED6F0DBED3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5DC5-1FF3-4E8E-8076-08F2EA2F0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73055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FD672B4-3F2E-4312-91E3-3DF5D337EF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14A40A-66D0-4BAE-9143-43D53B3CEBAB}" type="datetimeFigureOut">
              <a:rPr kumimoji="1" lang="ja-JP" altLang="en-US" smtClean="0"/>
              <a:t>2023/1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1DD0436-D808-4015-B5DE-475B06F74E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40F57F9-D68F-49BC-9DA9-8209A5DCF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5DC5-1FF3-4E8E-8076-08F2EA2F0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9355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25A11B9-F0A2-437A-913F-1FD2185DBA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EAFF95C-B87C-4A4B-903D-54688484614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D183FD3-5F0F-45C5-BBC6-2E7A7C1970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215B0B6-55C3-4CE8-8EB2-5A69461FF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14A40A-66D0-4BAE-9143-43D53B3CEBAB}" type="datetimeFigureOut">
              <a:rPr kumimoji="1" lang="ja-JP" altLang="en-US" smtClean="0"/>
              <a:t>2023/1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2A3F63D-6F48-4428-828F-12156AAB10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0A35363-7692-46EE-B391-08E91DA95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5DC5-1FF3-4E8E-8076-08F2EA2F0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2618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B4CBB5-2CB6-461B-94EF-30179A8776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28CF7F1-0DA4-40C1-8755-A37452CECDA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A75B359-3FB1-4BF3-9D27-05F87A2139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1E3BF28-7A8B-4493-B16A-A47717E1B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14A40A-66D0-4BAE-9143-43D53B3CEBAB}" type="datetimeFigureOut">
              <a:rPr kumimoji="1" lang="ja-JP" altLang="en-US" smtClean="0"/>
              <a:t>2023/1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EDBC68C-B3BE-4E0D-BAD9-CB6E76DD02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4985FA3-B36D-40C2-B784-60EA1E07D1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5DC5-1FF3-4E8E-8076-08F2EA2F0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29093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478A304-63E0-4118-B922-DC3469A96F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706CF62-A5D5-4A40-9B74-7CDF969E8F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D5AB720-3A2D-4A23-ABB9-B25FB8B8D31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14A40A-66D0-4BAE-9143-43D53B3CEBAB}" type="datetimeFigureOut">
              <a:rPr kumimoji="1" lang="ja-JP" altLang="en-US" smtClean="0"/>
              <a:t>2023/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E6A2897-38AB-4704-9CB3-06E2A22243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E437AF7-C12F-45A4-9B0F-27182B938FD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0D5DC5-1FF3-4E8E-8076-08F2EA2F0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77682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104C083-B018-4105-855D-83181E53D694}"/>
              </a:ext>
            </a:extLst>
          </p:cNvPr>
          <p:cNvSpPr txBox="1"/>
          <p:nvPr/>
        </p:nvSpPr>
        <p:spPr>
          <a:xfrm>
            <a:off x="911753" y="1021136"/>
            <a:ext cx="4307589" cy="92333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28575"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lung 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ncer who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u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erwent resection between 2012 and 2019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632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D726094-D7FB-412A-A4F8-C175E7D922D8}"/>
              </a:ext>
            </a:extLst>
          </p:cNvPr>
          <p:cNvSpPr txBox="1"/>
          <p:nvPr/>
        </p:nvSpPr>
        <p:spPr>
          <a:xfrm>
            <a:off x="2343150" y="3431540"/>
            <a:ext cx="38266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k of preoperative [</a:t>
            </a:r>
            <a:r>
              <a:rPr lang="ja-JP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r>
              <a:rPr lang="ja-JP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]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DG-PET/CT imaging</a:t>
            </a:r>
          </a:p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1 patient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B5A1A4B-4481-4352-8CB9-D83D9B9D72B0}"/>
              </a:ext>
            </a:extLst>
          </p:cNvPr>
          <p:cNvSpPr txBox="1"/>
          <p:nvPr/>
        </p:nvSpPr>
        <p:spPr>
          <a:xfrm>
            <a:off x="911753" y="5441834"/>
            <a:ext cx="7406836" cy="64633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28575"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lung </a:t>
            </a:r>
            <a:r>
              <a:rPr kumimoji="1"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ncer and available preoperative </a:t>
            </a:r>
            <a:r>
              <a:rPr lang="ja-JP" altLang="ja-JP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r>
              <a:rPr lang="ja-JP" altLang="ja-JP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-</a:t>
            </a:r>
            <a:r>
              <a:rPr kumimoji="1"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DG-PET/CT image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22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3BC6EA8-3C2C-40BD-9F87-A9FFFE00B6EC}"/>
              </a:ext>
            </a:extLst>
          </p:cNvPr>
          <p:cNvSpPr txBox="1"/>
          <p:nvPr/>
        </p:nvSpPr>
        <p:spPr>
          <a:xfrm>
            <a:off x="2343150" y="2810445"/>
            <a:ext cx="240001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k of lymph node dissection</a:t>
            </a:r>
          </a:p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4 patient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F0F5389-4B5C-43A6-B294-87D22A8517EC}"/>
              </a:ext>
            </a:extLst>
          </p:cNvPr>
          <p:cNvSpPr txBox="1"/>
          <p:nvPr/>
        </p:nvSpPr>
        <p:spPr>
          <a:xfrm>
            <a:off x="2343150" y="4101567"/>
            <a:ext cx="874790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k of adequate preoperative [</a:t>
            </a:r>
            <a:r>
              <a:rPr lang="ja-JP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r>
              <a:rPr lang="ja-JP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]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DG-PET/CT imaging data</a:t>
            </a:r>
          </a:p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4 patients (including 79 patients examined in other hospitals and 135 patients with mismatched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spection devices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6EC8EC20-9B98-4239-B0B2-065AEB709A5B}"/>
              </a:ext>
            </a:extLst>
          </p:cNvPr>
          <p:cNvCxnSpPr>
            <a:cxnSpLocks/>
          </p:cNvCxnSpPr>
          <p:nvPr/>
        </p:nvCxnSpPr>
        <p:spPr>
          <a:xfrm flipH="1">
            <a:off x="1739667" y="1944466"/>
            <a:ext cx="1" cy="3497368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1B714BB7-3D65-4BA1-B88A-2D452C8E0760}"/>
              </a:ext>
            </a:extLst>
          </p:cNvPr>
          <p:cNvCxnSpPr>
            <a:cxnSpLocks/>
          </p:cNvCxnSpPr>
          <p:nvPr/>
        </p:nvCxnSpPr>
        <p:spPr>
          <a:xfrm>
            <a:off x="1739667" y="3056986"/>
            <a:ext cx="603483" cy="4228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3CDDF287-E534-436E-A780-A65979B04B81}"/>
              </a:ext>
            </a:extLst>
          </p:cNvPr>
          <p:cNvCxnSpPr>
            <a:cxnSpLocks/>
          </p:cNvCxnSpPr>
          <p:nvPr/>
        </p:nvCxnSpPr>
        <p:spPr>
          <a:xfrm>
            <a:off x="1739667" y="3686808"/>
            <a:ext cx="603483" cy="4228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2C298B70-953B-4F5C-A3B5-23E4A98384CD}"/>
              </a:ext>
            </a:extLst>
          </p:cNvPr>
          <p:cNvCxnSpPr>
            <a:cxnSpLocks/>
          </p:cNvCxnSpPr>
          <p:nvPr/>
        </p:nvCxnSpPr>
        <p:spPr>
          <a:xfrm>
            <a:off x="1739667" y="4309428"/>
            <a:ext cx="603483" cy="4228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9A6F63B-62F9-448C-8B1D-DDA289EB4FEE}"/>
              </a:ext>
            </a:extLst>
          </p:cNvPr>
          <p:cNvSpPr txBox="1"/>
          <p:nvPr/>
        </p:nvSpPr>
        <p:spPr>
          <a:xfrm>
            <a:off x="2177393" y="95145"/>
            <a:ext cx="7837214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24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ＭＳ Ｐゴシック" charset="-128"/>
                <a:cs typeface="Times New Roman" panose="02020603050405020304" pitchFamily="18" charset="0"/>
              </a:rPr>
              <a:t>Supplement Figure S1. Patient selection flow chart</a:t>
            </a:r>
          </a:p>
          <a:p>
            <a:pPr algn="ctr"/>
            <a:r>
              <a:rPr kumimoji="1" lang="en-US" altLang="ja-JP" sz="24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ＭＳ Ｐゴシック" charset="-128"/>
                <a:cs typeface="Times New Roman" panose="02020603050405020304" pitchFamily="18" charset="0"/>
              </a:rPr>
              <a:t> Ito R. </a:t>
            </a:r>
            <a:r>
              <a:rPr kumimoji="1" lang="en-US" altLang="ja-JP" sz="2400" b="1" i="1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ＭＳ Ｐゴシック" charset="-128"/>
                <a:cs typeface="Times New Roman" panose="02020603050405020304" pitchFamily="18" charset="0"/>
              </a:rPr>
              <a:t>et al.</a:t>
            </a:r>
            <a:endParaRPr lang="ja-JP" altLang="en-US" sz="1200" i="1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912A505-E4CC-1EA7-5475-C8171DA061A0}"/>
              </a:ext>
            </a:extLst>
          </p:cNvPr>
          <p:cNvSpPr txBox="1"/>
          <p:nvPr/>
        </p:nvSpPr>
        <p:spPr>
          <a:xfrm>
            <a:off x="873409" y="6335380"/>
            <a:ext cx="748352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legend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Of the 632 patients with primary lung cancer, 223 patients were enrolled in this study. 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ja-JP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r>
              <a:rPr lang="ja-JP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]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DG-PET/CT, </a:t>
            </a:r>
            <a:r>
              <a:rPr lang="ja-JP" altLang="ja-JP" sz="1400" dirty="0">
                <a:solidFill>
                  <a:srgbClr val="2E2E2E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ja-JP" altLang="ja-JP" sz="1400" baseline="30000" dirty="0">
                <a:solidFill>
                  <a:srgbClr val="2E2E2E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r>
              <a:rPr lang="ja-JP" altLang="ja-JP" sz="1400" dirty="0">
                <a:solidFill>
                  <a:srgbClr val="2E2E2E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]fluorodeoxyglucose</a:t>
            </a:r>
            <a:r>
              <a:rPr lang="ja-JP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ositron emission tomography/computed tomography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384691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1</TotalTime>
  <Words>132</Words>
  <Application>Microsoft Office PowerPoint</Application>
  <PresentationFormat>ワイド画面</PresentationFormat>
  <Paragraphs>1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伊藤　龍一</dc:creator>
  <cp:lastModifiedBy>伊藤　龍一</cp:lastModifiedBy>
  <cp:revision>3</cp:revision>
  <dcterms:created xsi:type="dcterms:W3CDTF">2022-02-09T14:55:55Z</dcterms:created>
  <dcterms:modified xsi:type="dcterms:W3CDTF">2023-01-12T10:38:15Z</dcterms:modified>
</cp:coreProperties>
</file>